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BD7082-2C2C-4544-B676-7B672F563FD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1F1705-E712-4C5A-9B03-CBF07BEDD19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5B6402-B535-402D-AFAB-4B8D67ECBE5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6D1DB6-014F-47BD-94FF-1F516963863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D02D14-396C-4662-8045-61E15013B87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3D48FE-D1C5-4C4B-80CD-D99BFFB5A58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A2260D-7FE3-489C-8896-BB62262444B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04141E-A2D7-4023-ABE5-E8F6864929E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B337DC-0779-49E6-94BE-5565CA26EC9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B7A8FF-46A6-4E8D-90E9-0573047419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DD260B-BFA9-4076-A9BC-217397D06F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3FB11C-EDE5-4D62-93D0-A008B0467FD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E78EF1B-0F91-416E-902E-88A04234FCE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250920" y="189000"/>
          <a:ext cx="8640720" cy="6041880"/>
        </p:xfrm>
        <a:graphic>
          <a:graphicData uri="http://schemas.openxmlformats.org/drawingml/2006/table">
            <a:tbl>
              <a:tblPr/>
              <a:tblGrid>
                <a:gridCol w="720720"/>
                <a:gridCol w="863640"/>
                <a:gridCol w="2612880"/>
                <a:gridCol w="4443480"/>
              </a:tblGrid>
              <a:tr h="242640">
                <a:tc gridSpan="4"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Supplementary Table 2                          Summary of commentary on NHS ethical code of practice in relation to updates </a:t>
                      </a: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(abbreviations listed at end of manuscript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351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Year of publicatio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3f3f3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Type of documen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3f3f3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Title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3f3f3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Summary of conten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3f3f3"/>
                    </a:solidFill>
                  </a:tcPr>
                </a:tc>
              </a:tr>
              <a:tr h="2318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99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DH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Guidance on International Nursing Recruitment</a:t>
                      </a:r>
                      <a:r>
                        <a:rPr b="0" lang="en-GB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9190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00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DH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ode of Practice for NHS employers involved in the international recruitment of healthcare professionals</a:t>
                      </a:r>
                      <a:r>
                        <a:rPr b="0" lang="en-GB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Aimed to “prevent targeted recruitment from developing nations who are themselves experiencing shortages of healthcare staff”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tated that NHS advertising should occur in developing countries except by specific invitatio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Did not apply to recruitment to training positions such as senior house officer (SHO), or to health workers who “volunteer themselves through personal application”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953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0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Immigratio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Publication of list of 151 prohibited countries for active recruitment</a:t>
                      </a:r>
                      <a:r>
                        <a:rPr b="0" lang="en-GB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Based on OECD list of aid recipient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254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00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Report for DFI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International Recruitment of Health Workers to the UK: a report for DFID</a:t>
                      </a:r>
                      <a:r>
                        <a:rPr b="0" lang="en-GB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riticisms of Code of Practice: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buClr>
                          <a:srgbClr val="000000"/>
                        </a:buClr>
                        <a:buFont typeface="Calibri"/>
                        <a:buChar char="-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ode established in 2001, but list of proscribed countries not available until 20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buClr>
                          <a:srgbClr val="000000"/>
                        </a:buClr>
                        <a:buFont typeface="Calibri"/>
                        <a:buChar char="-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Did not apply to private sect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buClr>
                          <a:srgbClr val="000000"/>
                        </a:buClr>
                        <a:buFont typeface="Calibri"/>
                        <a:buChar char="-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Did not apply to non-NHS recruitmen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buClr>
                          <a:srgbClr val="000000"/>
                        </a:buClr>
                        <a:buFont typeface="Calibri"/>
                        <a:buChar char="-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ompliance not transparen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buClr>
                          <a:srgbClr val="000000"/>
                        </a:buClr>
                        <a:buFont typeface="Calibri"/>
                        <a:buChar char="-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Did not relate to non-active recruitmen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buClr>
                          <a:srgbClr val="000000"/>
                        </a:buClr>
                        <a:buFont typeface="Calibri"/>
                        <a:buChar char="-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Recruitment of private health workers from South Africa was not found to be breaking the Cod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buClr>
                          <a:srgbClr val="000000"/>
                        </a:buClr>
                        <a:buFont typeface="Calibri"/>
                        <a:buChar char="-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Globally targeted internet recruitment was commo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buClr>
                          <a:srgbClr val="000000"/>
                        </a:buClr>
                        <a:buFont typeface="Calibri"/>
                        <a:buChar char="-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Allowed movement from private to NHS employment once in the UK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9194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00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International Development Committee repor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Migration and Development: how to make migration work for poverty reduction</a:t>
                      </a:r>
                      <a:r>
                        <a:rPr b="0" lang="en-GB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riticisms of Code of Practic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buClr>
                          <a:srgbClr val="000000"/>
                        </a:buClr>
                        <a:buFont typeface="Calibri"/>
                        <a:buChar char="-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ode was voluntar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buClr>
                          <a:srgbClr val="000000"/>
                        </a:buClr>
                        <a:buFont typeface="Calibri"/>
                        <a:buChar char="-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No restrictions to passive recruitmen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buClr>
                          <a:srgbClr val="000000"/>
                        </a:buClr>
                        <a:buFont typeface="Calibri"/>
                        <a:buChar char="-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Only applied to Englan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buClr>
                          <a:srgbClr val="000000"/>
                        </a:buClr>
                        <a:buFont typeface="Calibri"/>
                        <a:buChar char="-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Did not apply to private sect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77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00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DH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ode of Practice for the international recruitment of healthcare professionals</a:t>
                      </a:r>
                      <a:r>
                        <a:rPr b="0" lang="en-GB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buClr>
                          <a:srgbClr val="000000"/>
                        </a:buClr>
                        <a:buFont typeface="Calibri"/>
                        <a:buChar char="-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Encouraged adoption by private sect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buClr>
                          <a:srgbClr val="000000"/>
                        </a:buClr>
                        <a:buFont typeface="Calibri"/>
                        <a:buChar char="-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Included non-permanent staf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buClr>
                          <a:srgbClr val="000000"/>
                        </a:buClr>
                        <a:buFont typeface="Calibri"/>
                        <a:buChar char="-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Best practice benchmarks provide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buClr>
                          <a:srgbClr val="000000"/>
                        </a:buClr>
                        <a:buFont typeface="Calibri"/>
                        <a:buChar char="-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Allowed 12 month deadline for recruitment agencies to compl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953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00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he Impact of the Department of Health, England, Code of Practice on International Recruitment</a:t>
                      </a:r>
                      <a:r>
                        <a:rPr b="0" lang="en-GB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Impact of Code of Practice would only be known at a future time when the UK required active recruitment again from overseas, because of important confounding factor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15T16:03:45Z</dcterms:created>
  <dc:creator>cblacklock</dc:creator>
  <dc:description/>
  <dc:language>en-US</dc:language>
  <cp:lastModifiedBy>cblacklock</cp:lastModifiedBy>
  <dcterms:modified xsi:type="dcterms:W3CDTF">2011-11-24T18:10:35Z</dcterms:modified>
  <cp:revision>10</cp:revision>
  <dc:subject/>
  <dc:title>Slide 1</dc:title>
</cp:coreProperties>
</file>